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6"/>
  </p:notesMasterIdLst>
  <p:sldIdLst>
    <p:sldId id="313" r:id="rId5"/>
  </p:sldIdLst>
  <p:sldSz cx="12192000" cy="6858000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831" autoAdjust="0"/>
    <p:restoredTop sz="86847" autoAdjust="0"/>
  </p:normalViewPr>
  <p:slideViewPr>
    <p:cSldViewPr snapToGrid="0" showGuides="1">
      <p:cViewPr varScale="1">
        <p:scale>
          <a:sx n="110" d="100"/>
          <a:sy n="110" d="100"/>
        </p:scale>
        <p:origin x="984" y="12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72B54F-A3F7-4066-9A04-CC5B84A6A702}" type="datetimeFigureOut">
              <a:rPr kumimoji="1" lang="ja-JP" altLang="en-US" smtClean="0"/>
              <a:t>2024/10/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09575" y="1233488"/>
            <a:ext cx="591661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8163"/>
            <a:ext cx="5388610" cy="38848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1A689A1-84A7-4B0C-A9C8-9885B07BCF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26274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3B2619E-23C4-450A-8735-D6A9CB0D9BE5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68234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3CEA7B1-EAF5-F6F6-4F9E-B8F9C35CE11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37234302-FB9B-C4F6-CFD1-1A989359A51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5277B34-9600-AAFB-3117-0BF450506A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048CA5-594A-4FD6-A171-A0041500D24A}" type="datetime1">
              <a:rPr kumimoji="1" lang="ja-JP" altLang="en-US" smtClean="0"/>
              <a:t>2024/10/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9A5E35B-EB0E-0811-E149-F78C84F346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ABEAEE4-47C2-1FA5-8EA1-A009300154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27D70-E7E3-474D-ABEA-1CF46C4428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36981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B3453DA-BD6D-5C09-339F-B09791AD1F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BDACCCA-C3D5-A39C-979B-CE3E01E8EB4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68AC13C-C495-741A-2941-6FF09D82D4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8B3AC-104A-4B9D-AA8E-B032C0C622A4}" type="datetime1">
              <a:rPr kumimoji="1" lang="ja-JP" altLang="en-US" smtClean="0"/>
              <a:t>2024/10/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C5F5ACC-2E74-DA4E-AC7C-639A53D213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37FDFDA-C8CC-3771-6690-64669DAF23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27D70-E7E3-474D-ABEA-1CF46C4428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47191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B2C89792-E522-02FD-E612-27A2C0C2E6B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DAFF38B-5582-C22D-6348-6E296AC8D89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B5CC90B-3133-99A8-C31B-56FB438A2E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1D5E6-2BFD-4FB2-A40F-FBCC8B157DB4}" type="datetime1">
              <a:rPr kumimoji="1" lang="ja-JP" altLang="en-US" smtClean="0"/>
              <a:t>2024/10/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397BF3A-4E8C-0533-AB6D-2346DB42AE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F6C8935-A6CD-4E3D-0FFA-468B0DFFDF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27D70-E7E3-474D-ABEA-1CF46C4428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32713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B9DE9B2-9254-1EAD-0189-721665C9F7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18A30D5-B4A4-D51C-F451-96FBBBC0E9D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30015F8-D6CF-8F35-DA25-CF54FB49E0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A5E1F-B379-4267-B518-72E99731E2B2}" type="datetime1">
              <a:rPr kumimoji="1" lang="ja-JP" altLang="en-US" smtClean="0"/>
              <a:t>2024/10/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D98DDB5-4AA7-4FB1-7FBE-75900C2FF6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EFA11D3-D739-7355-845D-9E73C27F78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27D70-E7E3-474D-ABEA-1CF46C4428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25612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DD8BA5F-5BDB-41C7-9EA8-317796D666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202A257-5D16-7EC5-F3BA-CF32868807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CB8C460-F1F1-9ACB-B092-CEBA2920ED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63414B-7F6C-4AFA-B926-EA68E75024C7}" type="datetime1">
              <a:rPr kumimoji="1" lang="ja-JP" altLang="en-US" smtClean="0"/>
              <a:t>2024/10/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FDFC7FE-1BEA-32C9-1306-E592968B57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316DD85-1C87-476C-7853-427813A53A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27D70-E7E3-474D-ABEA-1CF46C4428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71329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33044AC-845A-538E-E199-26C4909276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F5D9316-EF4E-729B-D577-CC3CB4F0325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0277D70-0DBD-FEB8-45F3-D7AE5F71C0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CEDFD01-1CF6-EB46-33E0-0B7334461D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2A9C59-8848-4E8C-879E-9D6DC2EEFDA3}" type="datetime1">
              <a:rPr kumimoji="1" lang="ja-JP" altLang="en-US" smtClean="0"/>
              <a:t>2024/10/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02B0481-CAED-888B-06A1-2DE436E870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3DF975F-2805-C3BC-3B0D-08D4AEEB26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27D70-E7E3-474D-ABEA-1CF46C4428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91007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63385CB-71AE-3AAA-DC3C-B0718FA7F4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8CA7C94-16F1-48A1-5F60-B37A76931E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A37EEF3-15FE-8B2B-B6C7-7594B6AE3D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6656DD27-1180-6D62-18EC-972A9B9D2BB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8DCAA571-47A7-2411-31E8-D06DDBDBB52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009EB1BC-3590-F62E-94C5-02FF09D227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711EA-580A-4B06-B6B6-ADF8C0AF0A8C}" type="datetime1">
              <a:rPr kumimoji="1" lang="ja-JP" altLang="en-US" smtClean="0"/>
              <a:t>2024/10/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B4CB754A-0402-43B3-5BF7-C77E3CB750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2016244D-04AF-F2C5-4371-3E3CA86559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27D70-E7E3-474D-ABEA-1CF46C4428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74431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7EC308F-713D-C416-7AA0-C94A11D7E4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5584A759-0527-64C7-0663-33BF4C092C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A0669A-FA0D-4934-8C67-E423B35C1911}" type="datetime1">
              <a:rPr kumimoji="1" lang="ja-JP" altLang="en-US" smtClean="0"/>
              <a:t>2024/10/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3FEF4A23-5FB5-ADA0-0940-A60F0E91BA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5E62151D-18E3-C655-AEDA-163E21FB67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27D70-E7E3-474D-ABEA-1CF46C4428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09435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F5F22CC6-B07E-4ED5-5B44-9C21225E2F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3A0BC-0ED9-4FCB-8F5C-CF9D286622B2}" type="datetime1">
              <a:rPr kumimoji="1" lang="ja-JP" altLang="en-US" smtClean="0"/>
              <a:t>2024/10/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9BBE331D-BCA5-2741-32F6-AF0A74535C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F90D41D-0B0A-56D4-61F2-491DCA9B3B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27D70-E7E3-474D-ABEA-1CF46C4428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12243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287CE2C-CD99-3502-5AC4-D042C55DDD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536E711-2A50-1BC9-D810-27446DB4372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A9C4D70-B8B2-D263-406F-92DECFEF358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70FECD2-38C7-D6E6-4DA9-8B6BA92170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8D329-6B35-4C23-9C04-908DD2DAC0C8}" type="datetime1">
              <a:rPr kumimoji="1" lang="ja-JP" altLang="en-US" smtClean="0"/>
              <a:t>2024/10/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C058D6D-0B9C-FFD8-3982-BC53BDAC55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5A8658D-6C7D-C881-559D-CC9BF404C5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27D70-E7E3-474D-ABEA-1CF46C4428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88281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13866AA-1DAF-AF35-6149-AF7F0E6EC1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CF7792AF-E74A-5BB5-E2F5-F3A0FA31E64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156811C-AD0D-1356-C295-2CD178FCF56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E2AB96F-4BDB-9C46-949A-73CE057B7E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C0557-F8C8-49E7-A81C-0D22A72B9AFC}" type="datetime1">
              <a:rPr kumimoji="1" lang="ja-JP" altLang="en-US" smtClean="0"/>
              <a:t>2024/10/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F5DFACB-6E7E-6B99-18AC-D1B892E097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9C2E8F5-4072-0230-6B82-39BEFD2CEC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27D70-E7E3-474D-ABEA-1CF46C4428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48180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EFF4B6AC-927C-1323-4755-9F39AAE7AA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C822034-1EA4-0582-4644-8447C88D31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7FC376D-7FAA-52DE-F40E-2A98EC4E1BA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3D0019-610F-4923-B3B0-5522339B6F02}" type="datetime1">
              <a:rPr kumimoji="1" lang="ja-JP" altLang="en-US" smtClean="0"/>
              <a:t>2024/10/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BE14C38-5FEA-7423-3439-B71A186FD10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C554980-4EBB-9DED-3895-DC44A4846B6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A27D70-E7E3-474D-ABEA-1CF46C4428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94161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3">
            <a:extLst>
              <a:ext uri="{FF2B5EF4-FFF2-40B4-BE49-F238E27FC236}">
                <a16:creationId xmlns:a16="http://schemas.microsoft.com/office/drawing/2014/main" id="{BBE3BAD2-B84D-F536-00E9-A737D0506A6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86269391"/>
              </p:ext>
            </p:extLst>
          </p:nvPr>
        </p:nvGraphicFramePr>
        <p:xfrm>
          <a:off x="879231" y="449683"/>
          <a:ext cx="10474569" cy="627178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515071">
                  <a:extLst>
                    <a:ext uri="{9D8B030D-6E8A-4147-A177-3AD203B41FA5}">
                      <a16:colId xmlns:a16="http://schemas.microsoft.com/office/drawing/2014/main" val="788053838"/>
                    </a:ext>
                  </a:extLst>
                </a:gridCol>
                <a:gridCol w="2060067">
                  <a:extLst>
                    <a:ext uri="{9D8B030D-6E8A-4147-A177-3AD203B41FA5}">
                      <a16:colId xmlns:a16="http://schemas.microsoft.com/office/drawing/2014/main" val="89759541"/>
                    </a:ext>
                  </a:extLst>
                </a:gridCol>
                <a:gridCol w="911180">
                  <a:extLst>
                    <a:ext uri="{9D8B030D-6E8A-4147-A177-3AD203B41FA5}">
                      <a16:colId xmlns:a16="http://schemas.microsoft.com/office/drawing/2014/main" val="1542895843"/>
                    </a:ext>
                  </a:extLst>
                </a:gridCol>
                <a:gridCol w="1846769">
                  <a:extLst>
                    <a:ext uri="{9D8B030D-6E8A-4147-A177-3AD203B41FA5}">
                      <a16:colId xmlns:a16="http://schemas.microsoft.com/office/drawing/2014/main" val="2983619985"/>
                    </a:ext>
                  </a:extLst>
                </a:gridCol>
                <a:gridCol w="1141482">
                  <a:extLst>
                    <a:ext uri="{9D8B030D-6E8A-4147-A177-3AD203B41FA5}">
                      <a16:colId xmlns:a16="http://schemas.microsoft.com/office/drawing/2014/main" val="2788178326"/>
                    </a:ext>
                  </a:extLst>
                </a:gridCol>
              </a:tblGrid>
              <a:tr h="483696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aracteristics</a:t>
                      </a:r>
                      <a:endParaRPr kumimoji="1" lang="ja-JP" altLang="en-US" sz="12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</a:t>
                      </a:r>
                    </a:p>
                    <a:p>
                      <a:pPr algn="ctr"/>
                      <a:r>
                        <a:rPr kumimoji="1" lang="en-US" altLang="ja-JP" sz="120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dds ratio (95% CI)</a:t>
                      </a:r>
                      <a:endParaRPr kumimoji="1" lang="ja-JP" altLang="en-US" sz="12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endParaRPr kumimoji="1" lang="ja-JP" altLang="en-US" sz="12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dds ratio (95% CI)</a:t>
                      </a:r>
                      <a:endParaRPr kumimoji="1" lang="ja-JP" altLang="en-US" sz="12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endParaRPr kumimoji="1" lang="ja-JP" altLang="en-US" sz="12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682330197"/>
                  </a:ext>
                </a:extLst>
              </a:tr>
              <a:tr h="290217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 (&gt;60 </a:t>
                      </a:r>
                      <a:r>
                        <a:rPr kumimoji="1" lang="en-US" altLang="ja-JP" sz="12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.o</a:t>
                      </a:r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 </a:t>
                      </a:r>
                      <a:r>
                        <a:rPr kumimoji="1" lang="en-US" altLang="ja-JP" sz="12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.s</a:t>
                      </a:r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 </a:t>
                      </a:r>
                      <a:r>
                        <a:rPr kumimoji="1" lang="en-US" altLang="ja-JP" sz="1200" u="sng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</a:t>
                      </a:r>
                      <a:r>
                        <a:rPr kumimoji="1" lang="ja-JP" altLang="en-US" sz="1200" u="none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sz="1200" u="none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y.o.)</a:t>
                      </a:r>
                      <a:endParaRPr kumimoji="1" lang="ja-JP" altLang="en-US" sz="1200" u="none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2 (0.61-1.08)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6 (1.13-1.62)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1</a:t>
                      </a:r>
                      <a:endParaRPr kumimoji="1" lang="ja-JP" altLang="en-US" sz="12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136233680"/>
                  </a:ext>
                </a:extLst>
              </a:tr>
              <a:tr h="329425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MI (&gt;25kg/m</a:t>
                      </a:r>
                      <a:r>
                        <a:rPr kumimoji="1" lang="en-US" altLang="ja-JP" sz="10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kumimoji="1" lang="en-US" altLang="ja-JP" sz="10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sz="1000" baseline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.s</a:t>
                      </a:r>
                      <a:r>
                        <a:rPr kumimoji="1" lang="en-US" altLang="ja-JP" sz="10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 </a:t>
                      </a:r>
                      <a:r>
                        <a:rPr kumimoji="1" lang="en-US" altLang="ja-JP" sz="1000" u="sng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</a:t>
                      </a:r>
                      <a:r>
                        <a:rPr kumimoji="1" lang="ja-JP" altLang="en-US" sz="1000" u="none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sz="10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kg/m</a:t>
                      </a:r>
                      <a:r>
                        <a:rPr kumimoji="1" lang="en-US" altLang="ja-JP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7 (0.65-1.16)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7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7 (1.50-2.32)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1</a:t>
                      </a:r>
                      <a:endParaRPr kumimoji="1" lang="ja-JP" altLang="en-US" sz="12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81886675"/>
                  </a:ext>
                </a:extLst>
              </a:tr>
              <a:tr h="290217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ertension 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1 (1.11-2.05)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1</a:t>
                      </a:r>
                      <a:endParaRPr kumimoji="1" lang="ja-JP" altLang="en-US" sz="12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3 (1.22-1.92)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1</a:t>
                      </a:r>
                      <a:endParaRPr kumimoji="1" lang="ja-JP" altLang="en-US" sz="12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712447705"/>
                  </a:ext>
                </a:extLst>
              </a:tr>
              <a:tr h="312280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yslipidemia 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1 (0.61-1.32)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3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4 (1.20-1.97)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1</a:t>
                      </a:r>
                      <a:endParaRPr kumimoji="1" lang="ja-JP" altLang="en-US" sz="12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297571981"/>
                  </a:ext>
                </a:extLst>
              </a:tr>
              <a:tr h="290217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abetes mellitus 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7 (1.15-2.40)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1</a:t>
                      </a:r>
                      <a:endParaRPr kumimoji="1" lang="ja-JP" altLang="en-US" sz="12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6 (0.84-1.89)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5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87427451"/>
                  </a:ext>
                </a:extLst>
              </a:tr>
              <a:tr h="310252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art failure 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9 (1.18-4.28)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</a:t>
                      </a:r>
                      <a:endParaRPr kumimoji="1" lang="ja-JP" altLang="en-US" sz="12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6 (0.49-2.25)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7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21603139"/>
                  </a:ext>
                </a:extLst>
              </a:tr>
              <a:tr h="310252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schemic heart disease 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6 (0.86-2.54)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0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1 (0.19-0.84)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</a:t>
                      </a:r>
                      <a:endParaRPr kumimoji="1" lang="ja-JP" altLang="en-US" sz="12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70427002"/>
                  </a:ext>
                </a:extLst>
              </a:tr>
              <a:tr h="310252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rebral stroke 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6 (0.69-2.52)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5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8</a:t>
                      </a:r>
                      <a:r>
                        <a:rPr kumimoji="1" lang="ja-JP" alt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0.33-1.35)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8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095777372"/>
                  </a:ext>
                </a:extLst>
              </a:tr>
              <a:tr h="305033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inal cord disorder 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2 (0.26-1.31)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2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4 (1.05-2.89)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</a:t>
                      </a:r>
                      <a:endParaRPr kumimoji="1" lang="ja-JP" altLang="en-US" sz="12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542538368"/>
                  </a:ext>
                </a:extLst>
              </a:tr>
              <a:tr h="319167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rological disorder 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6 (0.68-3.40)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7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6 (0.48-2.25)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8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194230867"/>
                  </a:ext>
                </a:extLst>
              </a:tr>
              <a:tr h="299028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cal incontinence 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8 (1.87-5.63)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1</a:t>
                      </a:r>
                      <a:endParaRPr kumimoji="1" lang="ja-JP" altLang="en-US" sz="12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0 (1.66-5.16)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1</a:t>
                      </a:r>
                      <a:endParaRPr kumimoji="1" lang="ja-JP" altLang="en-US" sz="12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46317623"/>
                  </a:ext>
                </a:extLst>
              </a:tr>
              <a:tr h="329603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stipation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7 (1.20-2.54)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1</a:t>
                      </a:r>
                      <a:endParaRPr kumimoji="1" lang="ja-JP" altLang="en-US" sz="12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4 (0.98-1.56)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6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130487333"/>
                  </a:ext>
                </a:extLst>
              </a:tr>
              <a:tr h="320183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requent spice intake 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5 (1.19-2.01)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1</a:t>
                      </a:r>
                      <a:endParaRPr kumimoji="1" lang="ja-JP" altLang="en-US" sz="12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9 (0.73-1.08)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6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641200479"/>
                  </a:ext>
                </a:extLst>
              </a:tr>
              <a:tr h="290217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requent caffeine intake 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6 (0.79-1.42)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8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3 (0.95-1.35)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5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019723056"/>
                  </a:ext>
                </a:extLst>
              </a:tr>
              <a:tr h="300929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inking habi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3 (1.10-1.87)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1</a:t>
                      </a:r>
                      <a:endParaRPr kumimoji="1" lang="ja-JP" altLang="en-US" sz="12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5 (0.76-1.18)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8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836139587"/>
                  </a:ext>
                </a:extLst>
              </a:tr>
              <a:tr h="295205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story of smoking 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2 (0.77-1.35)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8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4 (0.94-1.36)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82585883"/>
                  </a:ext>
                </a:extLst>
              </a:tr>
              <a:tr h="295205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enign prostatic hyperplasia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8 (0.93-2.30)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9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191414759"/>
                  </a:ext>
                </a:extLst>
              </a:tr>
              <a:tr h="295205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ectile dysfunction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0 (1.55-2.88)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1</a:t>
                      </a:r>
                      <a:endParaRPr kumimoji="1" lang="ja-JP" altLang="en-US" sz="12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906115267"/>
                  </a:ext>
                </a:extLst>
              </a:tr>
              <a:tr h="295205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ginal delivery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5 (1.77-2.63)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1</a:t>
                      </a:r>
                      <a:endParaRPr kumimoji="1" lang="ja-JP" altLang="en-US" sz="12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330924155"/>
                  </a:ext>
                </a:extLst>
              </a:tr>
            </a:tbl>
          </a:graphicData>
        </a:graphic>
      </p:graphicFrame>
      <p:sp>
        <p:nvSpPr>
          <p:cNvPr id="2" name="スライド番号プレースホルダー 1">
            <a:extLst>
              <a:ext uri="{FF2B5EF4-FFF2-40B4-BE49-F238E27FC236}">
                <a16:creationId xmlns:a16="http://schemas.microsoft.com/office/drawing/2014/main" id="{882BF6FA-CBCF-831F-2E1F-B79055A3B3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27D70-E7E3-474D-ABEA-1CF46C44285E}" type="slidenum">
              <a:rPr kumimoji="1" lang="ja-JP" altLang="en-US" smtClean="0"/>
              <a:t>1</a:t>
            </a:fld>
            <a:endParaRPr kumimoji="1" lang="ja-JP" altLang="en-US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85D7C926-E19E-5907-FC37-E81F6F588A4A}"/>
              </a:ext>
            </a:extLst>
          </p:cNvPr>
          <p:cNvSpPr txBox="1"/>
          <p:nvPr/>
        </p:nvSpPr>
        <p:spPr>
          <a:xfrm>
            <a:off x="1003458" y="14605"/>
            <a:ext cx="88240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Table. 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Logistic analyses for stress urinary incontinence both in male and female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368322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7A3625DB458FB740BC922AFE882DD9A2" ma:contentTypeVersion="9" ma:contentTypeDescription="新しいドキュメントを作成します。" ma:contentTypeScope="" ma:versionID="c3d3cc44f1cf8268b2a779800ca4f211">
  <xsd:schema xmlns:xsd="http://www.w3.org/2001/XMLSchema" xmlns:xs="http://www.w3.org/2001/XMLSchema" xmlns:p="http://schemas.microsoft.com/office/2006/metadata/properties" xmlns:ns3="53a630ee-c039-447c-bd30-d51d677b655e" targetNamespace="http://schemas.microsoft.com/office/2006/metadata/properties" ma:root="true" ma:fieldsID="c94956da269ba4215c5d19d95ae2237e" ns3:_="">
    <xsd:import namespace="53a630ee-c039-447c-bd30-d51d677b655e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ObjectDetectorVersions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3a630ee-c039-447c-bd30-d51d677b655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ObjectDetectorVersions" ma:index="1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8AEA1F2F-DB8E-4860-8E65-32E9038E9D9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53a630ee-c039-447c-bd30-d51d677b655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75FCEF19-24B1-4091-B44B-7DE1001F97DE}">
  <ds:schemaRefs>
    <ds:schemaRef ds:uri="http://purl.org/dc/elements/1.1/"/>
    <ds:schemaRef ds:uri="http://purl.org/dc/terms/"/>
    <ds:schemaRef ds:uri="http://schemas.microsoft.com/office/infopath/2007/PartnerControls"/>
    <ds:schemaRef ds:uri="http://schemas.openxmlformats.org/package/2006/metadata/core-properties"/>
    <ds:schemaRef ds:uri="http://purl.org/dc/dcmitype/"/>
    <ds:schemaRef ds:uri="http://schemas.microsoft.com/office/2006/documentManagement/types"/>
    <ds:schemaRef ds:uri="http://www.w3.org/XML/1998/namespace"/>
    <ds:schemaRef ds:uri="http://schemas.microsoft.com/office/2006/metadata/properties"/>
    <ds:schemaRef ds:uri="53a630ee-c039-447c-bd30-d51d677b655e"/>
  </ds:schemaRefs>
</ds:datastoreItem>
</file>

<file path=customXml/itemProps3.xml><?xml version="1.0" encoding="utf-8"?>
<ds:datastoreItem xmlns:ds="http://schemas.openxmlformats.org/officeDocument/2006/customXml" ds:itemID="{2F408BB8-5C5C-4A15-927F-6913678BD6F2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7780</TotalTime>
  <Words>296</Words>
  <Application>Microsoft Office PowerPoint</Application>
  <PresentationFormat>ワイド画面</PresentationFormat>
  <Paragraphs>105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和女</dc:creator>
  <cp:lastModifiedBy>羽賀　宣博</cp:lastModifiedBy>
  <cp:revision>57</cp:revision>
  <cp:lastPrinted>2023-12-24T08:23:14Z</cp:lastPrinted>
  <dcterms:created xsi:type="dcterms:W3CDTF">2023-11-27T12:54:25Z</dcterms:created>
  <dcterms:modified xsi:type="dcterms:W3CDTF">2024-10-02T04:54:1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A3625DB458FB740BC922AFE882DD9A2</vt:lpwstr>
  </property>
</Properties>
</file>